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816A2-7A56-E25E-10F9-45DE2A6436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7D94131-59F8-C36C-2FA2-0990E26831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97592C-40C3-9258-F568-6B2700561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CEEC7A-54CC-30A0-DBE6-3A2EF330A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62A04F-0964-5761-E7AD-74E7A4898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651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7FB3D-D83E-1B23-AA16-2DB6087793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8ACEA6-F64C-427C-C8D4-229636BB47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1FC2E6-BFF2-6CA0-CA3A-0B337DF9B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79658-B895-E8BF-2C5A-390031694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5E9673-7297-CFF4-A6F6-2359A43CD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838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8E8FB2-812F-D09E-DB7E-69E5B9FB3C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7EE058-EFA9-D02D-DD54-5AFBCDDF8A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F02266-E418-C05B-0DE5-815E02666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70E2AA-A6F1-E2A1-DDE6-2A1C24547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E03B2F-D793-F8CB-C46E-C537AEB9B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9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566B4-70B5-A12C-6B0F-966625B45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359CD9-9A60-6959-110B-048CEC1525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11E50D-26B3-0064-DFDD-E55621B56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8A16F3-3C93-5680-F01C-EDF5B7563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BCAA9-681B-065A-EE5F-5F6B6447F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850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DB54F9-66D7-D250-ECCD-1A98C6489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547AF0-DE2A-50F7-7CC5-540B90B82E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115F35-2B3A-1333-9894-B564DDD0C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EA57F-6B74-5059-A454-82B3F2CEB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2E058A-04D6-3769-702C-4804E85A6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668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E08C7-3660-E3AA-CD28-61E0A70B35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66CC21-94FA-0B99-68AD-72F4D7F8A6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FC5F02-A3DC-6396-9C8B-2FA39F944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26F56D-6AC4-8F99-257B-13A5CC8AD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FB39CF-8D77-C2B9-756B-0E3E0B2C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85F1D2-EB98-98AB-BEB5-555853962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219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D2C78-83E8-CDF5-A97B-C631DF935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7DC5A-2CFA-0EA0-5E08-C8E3DBE8E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14F628-0416-F8AE-9D4C-D52F8CE52D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F6248F-0E5B-D737-7758-F785C3A9DE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317B14-312A-06FA-ED22-29672A15F9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200321-A2A3-22A2-0765-A54727C98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56947A-98D4-BD11-9909-14F212C6A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C634C7-BDDC-E37E-C36F-FBB718B94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791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A6A59D-4326-AD21-9111-E009F42AA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19D4BF-AFEA-EE6C-13F8-C085438D3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D68A3E-54E5-58EB-950E-C443EB250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6028DF-B3CF-8CD2-5161-B0828FCCB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233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3886BF-8AA1-B0C4-4834-B551B7C20C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7589C-ABEE-8D91-C845-624FA5F18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FA5B0D-3D8C-C2DD-3965-AB03389AB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42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B72AD0-76CA-FA95-BDB9-3E3650044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23CD19-BB33-E13F-00F1-702FB3E54C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094052-6D02-9B8E-10F3-95F3CFD55B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C3EA1E-1716-685B-9B88-7D2A87E79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D3A834-CFE0-7F63-20AF-5A5961599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776288-06B5-892B-D5BE-F9529E62A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990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A2F713-24B1-DC86-1782-B2154D7FA9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83B6821-B6BB-4D6A-3ED4-8579996BF3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DD9CA0-BF0F-C88E-5DAC-590DFE613F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5973FB-795C-23C4-F88D-C7347BFA7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D45582-2231-CE87-F188-2F68029C4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F9823D-E47B-992A-AB69-F34DD27B3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943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DF997B-5472-DCAC-E922-67E87A2B1B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AC219F-77A2-08F2-988C-DC3DC82C8E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AB754-E871-CC09-0E4E-C98AA76827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0DE564-CF7C-7545-8595-A41A4A84DFF3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2EC3EE-8F11-BABE-4A50-97B9A7EE67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CCE85-68AB-66D8-2BEA-31DC4F5B61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01EF32-A417-9545-B79F-F8D9520D58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9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EB6B429-D88E-C830-747C-647FE0182A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8097" y="433552"/>
            <a:ext cx="7772400" cy="3886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A4C466C-784A-3F88-E202-85927290F6AA}"/>
              </a:ext>
            </a:extLst>
          </p:cNvPr>
          <p:cNvSpPr txBox="1"/>
          <p:nvPr/>
        </p:nvSpPr>
        <p:spPr>
          <a:xfrm>
            <a:off x="2522483" y="4908330"/>
            <a:ext cx="71470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Figure S3</a:t>
            </a:r>
            <a:r>
              <a:rPr lang="en-US" sz="900" dirty="0"/>
              <a:t>. Total number of Actinobacteria ASVs per sample compared to other bacterial family ASVs on normalized data</a:t>
            </a:r>
            <a:r>
              <a:rPr lang="en-US" sz="900" dirty="0">
                <a:effectLst/>
              </a:rPr>
              <a:t> 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41847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sea Masaki</dc:creator>
  <cp:lastModifiedBy>Hosea Masaki</cp:lastModifiedBy>
  <cp:revision>1</cp:revision>
  <dcterms:created xsi:type="dcterms:W3CDTF">2025-09-25T11:22:55Z</dcterms:created>
  <dcterms:modified xsi:type="dcterms:W3CDTF">2025-09-25T11:24:47Z</dcterms:modified>
</cp:coreProperties>
</file>